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CE5C88-C95E-8521-719B-CE0C20E4A4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12E3F2-9C68-B5FC-5199-10E6D6E980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9D886A-66DE-F4AE-B735-3981F81EA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EF560-AA3F-4766-BCB2-06A8DDA56D36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D78CDF-9C48-49F3-73A9-D3F59F929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6C1A38-E42D-67DE-F5A1-70195D3F1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25746-BB73-42F5-9CAC-41AE91DFCB3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45642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1B182F-46EE-8D34-6F36-1BC1803E3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B660CB-CE1E-AC3C-A920-9F648F89E7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B57D68-A1B8-CE37-1DC1-075787D7B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EF560-AA3F-4766-BCB2-06A8DDA56D36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395E2B-4C3D-FAED-E547-9B5614F8A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BE5136-EF89-4786-FE17-53E1923731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25746-BB73-42F5-9CAC-41AE91DFCB3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16192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E8E0E49-CE33-C10D-0EF9-2FE8ACA102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E0DD5A-DED6-FC8B-A5F6-ED0FBA6853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F02B69-5C0A-8CC1-7DB1-F55E2E413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EF560-AA3F-4766-BCB2-06A8DDA56D36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256DAB-06AE-6A4F-5BF6-7AE9ACF91A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8D27A0-B6B0-3C96-B5D2-6EE52800B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25746-BB73-42F5-9CAC-41AE91DFCB3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92555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2582AD-A885-2941-0B37-D772F18315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2CA45E-FBE8-753C-8D9B-6E0D219F62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9B31A8-2C17-0DF1-C3A9-2FE3BBFA77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EF560-AA3F-4766-BCB2-06A8DDA56D36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647BF0-0CB0-A208-D535-270597E5A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71968D-82C7-BB1B-91F8-30525EDDD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25746-BB73-42F5-9CAC-41AE91DFCB3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98145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770205-C1FD-1FDC-4F25-034EAFB2B6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68198B-2BE5-31DA-59BA-AE0DCB9C8E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2CB319-F9F4-D3D1-1D33-7F309BDAC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EF560-AA3F-4766-BCB2-06A8DDA56D36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32B98E-16FE-23CA-85C0-5D67E90B23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051F18-0403-2A6B-9AE6-352BAD718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25746-BB73-42F5-9CAC-41AE91DFCB3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29799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D13A41-743B-2147-599B-B7E2C2A7F1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510E3E-EB5C-EDFB-FBAD-EF546FF1FD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9DC620-5E3E-3AAE-D9BF-9F9B18EF93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A4295B-41D2-DF33-BF03-D546346E7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EF560-AA3F-4766-BCB2-06A8DDA56D36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5897D4-7624-6818-4911-902FE3B6D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C0DB5A-1D56-1BF6-0667-B5497696F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25746-BB73-42F5-9CAC-41AE91DFCB3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87408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F39C99-34F1-91E8-15C5-01020733A3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73C794-4856-A902-49C9-32DCCFC424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D36CD9-5836-5AA8-79DB-739FEED010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455C0E-F4C1-55BD-C17F-526FA5A2A7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DB6534-C107-9042-3C4D-F9ED2A0E7B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54D7F46-FE4B-7132-EDBE-326336C2A0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EF560-AA3F-4766-BCB2-06A8DDA56D36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3114A6E-7295-9947-17C6-D1578EB9E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67A7B1F-41C6-C85C-6EC0-4F889FDA8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25746-BB73-42F5-9CAC-41AE91DFCB3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113485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B1AB10-D929-DAA8-0939-4FDA7C2B3E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1F6549-5518-C4F0-9D63-C9C6E8C2C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EF560-AA3F-4766-BCB2-06A8DDA56D36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E4C9C55-812A-6250-4D0A-F25001688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B5590ED-4ED2-2359-C196-62F6B84E3B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25746-BB73-42F5-9CAC-41AE91DFCB3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62448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45EA1C-C7C0-05A4-B45C-A417AEBE9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EF560-AA3F-4766-BCB2-06A8DDA56D36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17FD31A-5E3B-1BE4-C2A5-8B6E4C33E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B7E88F-A4F1-B142-3381-A4D27D73B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25746-BB73-42F5-9CAC-41AE91DFCB3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56236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95B160-DDBD-B160-762B-F2F08DD2EA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1746F0-CDE0-C94A-F819-CD7E19747E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7F3C00-ACBE-8D40-EE74-5EDA0D04FF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4A0486-2202-B8BE-06E2-AB39C2A90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EF560-AA3F-4766-BCB2-06A8DDA56D36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6E4741-E074-5C0F-269A-636E168BAA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64B753-C5F6-2D83-F313-6D86A3F80C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25746-BB73-42F5-9CAC-41AE91DFCB3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15867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9396C7-8D2E-2A05-6D57-ABD4507565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B1078FF-A60C-41C1-25F6-CF65EA4C61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A1DFB3-1E3C-1F7B-81A5-6F42C48073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368B28-9AE4-15A1-6E14-7B013BF1D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EF560-AA3F-4766-BCB2-06A8DDA56D36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63BFBE-2462-1347-9B0F-DB7CAC377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5735BA-B673-1165-2CFB-3300E63FE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25746-BB73-42F5-9CAC-41AE91DFCB3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27575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9FACF62-2218-CED0-01A5-E73B01DF70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51F783-5A30-EBBE-1F3F-52A03C672B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CE2D87-958E-8814-D715-CB836BAA9F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7EF560-AA3F-4766-BCB2-06A8DDA56D36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68A6BD-7DA5-4972-D45F-E8F7EEC8E1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4EE645-CCF1-CCF6-C546-32BBBB956F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925746-BB73-42F5-9CAC-41AE91DFCB32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22038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4084F601-31B1-9A16-D3EA-83133CDDCC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3472" y="0"/>
            <a:ext cx="10795555" cy="607721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5616A80-D20F-4460-E9E3-21BE84AEEACB}"/>
              </a:ext>
            </a:extLst>
          </p:cNvPr>
          <p:cNvSpPr txBox="1"/>
          <p:nvPr/>
        </p:nvSpPr>
        <p:spPr>
          <a:xfrm>
            <a:off x="411061" y="6300132"/>
            <a:ext cx="115432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3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A line graph illustrating the relative percentage of all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uchnera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s, from annotated genomes available on the NCBI, plotted over their %GC content. The mean of all the %GC contents was plotted in red.</a:t>
            </a:r>
            <a:endParaRPr lang="en-ZA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ZA" sz="1200" dirty="0"/>
          </a:p>
        </p:txBody>
      </p:sp>
    </p:spTree>
    <p:extLst>
      <p:ext uri="{BB962C8B-B14F-4D97-AF65-F5344CB8AC3E}">
        <p14:creationId xmlns:p14="http://schemas.microsoft.com/office/powerpoint/2010/main" val="6742157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4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ger, Francois, Dr [nfvburger@sun.ac.za]</dc:creator>
  <cp:lastModifiedBy>Oberholster, A, Prof [ambo@sun.ac.za]</cp:lastModifiedBy>
  <cp:revision>5</cp:revision>
  <dcterms:created xsi:type="dcterms:W3CDTF">2023-09-27T10:46:42Z</dcterms:created>
  <dcterms:modified xsi:type="dcterms:W3CDTF">2024-01-17T12:33:24Z</dcterms:modified>
</cp:coreProperties>
</file>